
<file path=[Content_Types].xml><?xml version="1.0" encoding="utf-8"?>
<Types xmlns="http://schemas.openxmlformats.org/package/2006/content-types">
  <Default Extension="jpeg" ContentType="image/jpeg"/>
  <Default Extension="jpg" ContentType="image/jpeg"/>
  <Default Extension="mp4" ContentType="video/mp4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8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90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DBAF1B-8278-4964-8818-C3796EA16070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DF3BBB-7FD9-4036-AE15-C233E8AF1C6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27071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7298DA-4F9D-FAB2-55BD-C269AC24484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665E7CA-9FFA-51F4-B1C5-7214D878AB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F958F-B6D1-9A72-E9BA-9E9B5B9934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C9A2D0-29B0-5F3A-486A-02CCCD1492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23E381-EB1E-8E1F-FAB5-3ECC6A8EB1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653124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B808E3-A445-6A11-4982-806D4762CB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6A17FA-3F31-FEF1-E659-2FC177F388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05B808-7EE6-79D1-4EC6-48CB7E36C8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BFB91E-9783-71B5-5334-D92E19A06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14E817-30B4-520C-1690-086E8F360C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10897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CA0F1D4-5775-1B04-CFFC-C7F2950BA21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6BDC13-DC96-76A1-BA85-92774A4492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8E3F4A-5D4A-82F6-B088-76774B1268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982726-B54D-C789-9EB6-315260C153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61A568-59BC-DE07-B3CA-DF0329F21D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034164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A930CB-4AE0-032A-5692-D81CA12F27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A7FABA-8B01-B134-9CF9-4E26B88286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3D0B9D-3798-7D50-9702-AAEA4AC750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55ADFA-856E-E343-89AC-7D88E015E3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23788B-D56B-0304-8079-8D1AB6C5E6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01077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639C7D-F2D6-A4E0-A0D8-5830611112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BB438E-7CEF-E9C3-60D9-B9D0999CD4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AF4D46-8B70-35E8-07AB-DC394C35AA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7C3931-F308-55A0-1B60-0AD15111DC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845DCF-EFA4-37E3-991F-0159E67C72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347368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741EBB-D829-0E9D-8A37-888BBB2007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CC76F3-0F10-5DFA-B62C-939F1BD20B1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333A63-9B12-2DEB-2CE1-1AE3547EAD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9F5DEF-57A7-FA35-0DE6-487FB35141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A21536-D74D-842D-621A-5DD1AF3FB1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E2F49F-45E9-DA7D-E967-A5E00E62E9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7254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3EFBBF-F17F-12F4-E4C1-088DE060A2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C752EF-2A68-01E3-61A8-94BA0FEBD9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B877A6D-E365-ADAC-1A07-B82768F68D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73654B6-6CFE-61B2-3A16-AD648BBBC5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615FC14-2C18-1DD9-9060-5FB267AF9F6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F1FB786-0028-A983-B6CE-5EE067E5DF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E0582CD-B2E0-CBFC-BBE2-19EA86655D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5B00D54-0235-9CF2-1A29-9FD01E7F0A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3841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6369CD-4D23-8BFC-A542-2B92D890B2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DD21CBA-51F0-88AD-F604-832CE87D0F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ECD55CA-98E7-46CF-7AB4-AFABA09731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22784CE-83CC-2EAC-9FEB-ACC3B17B79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00137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4040D52-7C1E-AB1D-798F-8BAE652C98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7FFA8C7-33F2-02E5-7D2A-C0D1D77228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E02132B-E01A-6E46-F0F2-9273B9525F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89271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1D4B46-A811-C07C-A508-0DF86A2E81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4E3D39-C1C6-B4B2-94B5-E3AD251DAB4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25304D2-5DEA-1878-EA86-1275E25F19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E57E76-31E0-7F8D-E1F8-C0DAF968E4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D6A111-82FD-9CDC-74BA-FBE7EE29F6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1F2276-3ABC-51F8-BAED-E0F6F46D18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234590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B8B00F-6894-5048-42F0-6537E501A7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8E7382-68F0-8ADD-E54A-F075972BDA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7FB87C-D120-E599-35B8-DC76CD2395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E7358D-B640-B4AE-D58C-6E698B0706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29F8AA-1B45-7650-EE90-858F206DB6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B9F684-B59A-4A16-4297-6850B3B0A1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24482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0F27173-DD36-2C49-9885-E5F44228A6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3987A0-A5C9-B390-BE4B-D4F17764E4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9FF9C0-7219-1D1E-A1D4-A43C84BD67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DE0F85-0C1B-BA21-BF4A-39B26F1240D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91B6E6-E829-B6B3-FBEE-083D5C9CC2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99029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7" Type="http://schemas.openxmlformats.org/officeDocument/2006/relationships/image" Target="../media/image3.jp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microsoft.com/office/2007/relationships/hdphoto" Target="../media/hdphoto1.wdp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Untitled.mp4" descr="Untitled.mp4">
            <a:hlinkClick r:id="" action="ppaction://media"/>
            <a:extLst>
              <a:ext uri="{FF2B5EF4-FFF2-40B4-BE49-F238E27FC236}">
                <a16:creationId xmlns:a16="http://schemas.microsoft.com/office/drawing/2014/main" id="{86276533-191D-41BC-92D0-666DB2472E36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/>
          <a:srcRect l="22544"/>
          <a:stretch/>
        </p:blipFill>
        <p:spPr>
          <a:xfrm flipV="1">
            <a:off x="6783746" y="752174"/>
            <a:ext cx="4696040" cy="2830500"/>
          </a:xfrm>
          <a:prstGeom prst="rect">
            <a:avLst/>
          </a:prstGeom>
        </p:spPr>
      </p:pic>
      <p:sp>
        <p:nvSpPr>
          <p:cNvPr id="8" name="Can 11">
            <a:extLst>
              <a:ext uri="{FF2B5EF4-FFF2-40B4-BE49-F238E27FC236}">
                <a16:creationId xmlns:a16="http://schemas.microsoft.com/office/drawing/2014/main" id="{76E0E3E8-DE9A-4B2D-8018-C93E32F90689}"/>
              </a:ext>
            </a:extLst>
          </p:cNvPr>
          <p:cNvSpPr/>
          <p:nvPr/>
        </p:nvSpPr>
        <p:spPr>
          <a:xfrm rot="5400000">
            <a:off x="6273812" y="2482908"/>
            <a:ext cx="350276" cy="2889035"/>
          </a:xfrm>
          <a:prstGeom prst="can">
            <a:avLst/>
          </a:prstGeom>
          <a:gradFill flip="none" rotWithShape="1">
            <a:gsLst>
              <a:gs pos="15000">
                <a:srgbClr val="977FE7"/>
              </a:gs>
              <a:gs pos="0">
                <a:srgbClr val="7C59EE"/>
              </a:gs>
              <a:gs pos="84000">
                <a:schemeClr val="bg1">
                  <a:shade val="67500"/>
                  <a:satMod val="115000"/>
                </a:schemeClr>
              </a:gs>
              <a:gs pos="100000">
                <a:schemeClr val="bg1">
                  <a:shade val="100000"/>
                  <a:satMod val="115000"/>
                </a:schemeClr>
              </a:gs>
            </a:gsLst>
            <a:lin ang="2700000" scaled="1"/>
            <a:tileRect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marL="0" marR="0" lvl="0" indent="0" algn="ctr" defTabSz="68579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    UV Fiber</a:t>
            </a:r>
          </a:p>
        </p:txBody>
      </p:sp>
      <p:sp>
        <p:nvSpPr>
          <p:cNvPr id="10" name="Can 13">
            <a:extLst>
              <a:ext uri="{FF2B5EF4-FFF2-40B4-BE49-F238E27FC236}">
                <a16:creationId xmlns:a16="http://schemas.microsoft.com/office/drawing/2014/main" id="{BB2A6259-3EC2-4CBF-BBFE-BB267058EBCE}"/>
              </a:ext>
            </a:extLst>
          </p:cNvPr>
          <p:cNvSpPr/>
          <p:nvPr/>
        </p:nvSpPr>
        <p:spPr>
          <a:xfrm rot="5400000">
            <a:off x="2958208" y="3401002"/>
            <a:ext cx="461665" cy="2003917"/>
          </a:xfrm>
          <a:prstGeom prst="can">
            <a:avLst>
              <a:gd name="adj" fmla="val 29009"/>
            </a:avLst>
          </a:prstGeom>
          <a:solidFill>
            <a:srgbClr val="00B0F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wrap="square" rtlCol="0" anchor="t" anchorCtr="1">
            <a:spAutoFit/>
          </a:bodyPr>
          <a:lstStyle/>
          <a:p>
            <a:pPr marL="0" marR="0" lvl="0" indent="0" algn="ctr" defTabSz="68579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Guidewire</a:t>
            </a:r>
          </a:p>
        </p:txBody>
      </p:sp>
      <p:sp>
        <p:nvSpPr>
          <p:cNvPr id="15" name="Rounded Rectangle 26">
            <a:extLst>
              <a:ext uri="{FF2B5EF4-FFF2-40B4-BE49-F238E27FC236}">
                <a16:creationId xmlns:a16="http://schemas.microsoft.com/office/drawing/2014/main" id="{69C9611A-BBDB-4D5E-9DFE-9A10744C9905}"/>
              </a:ext>
            </a:extLst>
          </p:cNvPr>
          <p:cNvSpPr/>
          <p:nvPr/>
        </p:nvSpPr>
        <p:spPr>
          <a:xfrm>
            <a:off x="4939199" y="3740693"/>
            <a:ext cx="975484" cy="1347756"/>
          </a:xfrm>
          <a:prstGeom prst="roundRect">
            <a:avLst/>
          </a:prstGeom>
          <a:solidFill>
            <a:schemeClr val="bg1">
              <a:lumMod val="6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68579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oil</a:t>
            </a:r>
          </a:p>
        </p:txBody>
      </p:sp>
      <p:sp>
        <p:nvSpPr>
          <p:cNvPr id="16" name="Rounded Rectangle 27">
            <a:extLst>
              <a:ext uri="{FF2B5EF4-FFF2-40B4-BE49-F238E27FC236}">
                <a16:creationId xmlns:a16="http://schemas.microsoft.com/office/drawing/2014/main" id="{CA37B1B5-4FE2-4EC5-BFED-CF32587EA059}"/>
              </a:ext>
            </a:extLst>
          </p:cNvPr>
          <p:cNvSpPr/>
          <p:nvPr/>
        </p:nvSpPr>
        <p:spPr>
          <a:xfrm>
            <a:off x="7200689" y="3740693"/>
            <a:ext cx="975484" cy="1347756"/>
          </a:xfrm>
          <a:prstGeom prst="roundRect">
            <a:avLst/>
          </a:prstGeom>
          <a:solidFill>
            <a:schemeClr val="bg1">
              <a:lumMod val="6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68579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oil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63CA4580-C24A-40B9-8B5E-C56B8AE7147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ackgroundRemoval t="3247" b="96753" l="0" r="94828">
                        <a14:foregroundMark x1="35345" y1="25974" x2="38793" y2="34416"/>
                        <a14:foregroundMark x1="51724" y1="22727" x2="91379" y2="64286"/>
                        <a14:foregroundMark x1="91379" y1="64286" x2="26724" y2="57792"/>
                        <a14:foregroundMark x1="26724" y1="57792" x2="42241" y2="10390"/>
                        <a14:foregroundMark x1="42241" y1="10390" x2="77586" y2="51948"/>
                        <a14:foregroundMark x1="77586" y1="51948" x2="75862" y2="55195"/>
                        <a14:foregroundMark x1="80172" y1="45455" x2="61207" y2="14286"/>
                        <a14:foregroundMark x1="4310" y1="70130" x2="33621" y2="72078"/>
                        <a14:foregroundMark x1="81897" y1="33766" x2="81897" y2="33766"/>
                        <a14:foregroundMark x1="83621" y1="21429" x2="50000" y2="9091"/>
                        <a14:foregroundMark x1="83621" y1="74675" x2="93103" y2="46753"/>
                        <a14:foregroundMark x1="78448" y1="81169" x2="93103" y2="78571"/>
                        <a14:foregroundMark x1="94828" y1="77273" x2="94828" y2="77273"/>
                        <a14:foregroundMark x1="61207" y1="4545" x2="61207" y2="4545"/>
                        <a14:foregroundMark x1="87069" y1="75974" x2="87069" y2="75974"/>
                        <a14:foregroundMark x1="44828" y1="91558" x2="44828" y2="91558"/>
                        <a14:foregroundMark x1="91379" y1="73377" x2="91379" y2="73377"/>
                        <a14:foregroundMark x1="91379" y1="70130" x2="91379" y2="70130"/>
                        <a14:foregroundMark x1="91379" y1="44156" x2="91379" y2="44156"/>
                        <a14:foregroundMark x1="35345" y1="96753" x2="35345" y2="96753"/>
                      </a14:backgroundRemoval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211808" y="5535927"/>
            <a:ext cx="881095" cy="1169731"/>
          </a:xfrm>
          <a:prstGeom prst="rect">
            <a:avLst/>
          </a:prstGeom>
          <a:ln w="9525">
            <a:solidFill>
              <a:schemeClr val="bg1"/>
            </a:solidFill>
          </a:ln>
          <a:effectLst>
            <a:softEdge rad="0"/>
          </a:effectLst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9E325597-869F-40B3-BA7B-415DF43E08D4}"/>
              </a:ext>
            </a:extLst>
          </p:cNvPr>
          <p:cNvSpPr txBox="1"/>
          <p:nvPr/>
        </p:nvSpPr>
        <p:spPr>
          <a:xfrm>
            <a:off x="6910467" y="6501636"/>
            <a:ext cx="1002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68579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Light Sensor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441B6E7D-0303-4E11-AC0A-0249D1066D6E}"/>
              </a:ext>
            </a:extLst>
          </p:cNvPr>
          <p:cNvCxnSpPr>
            <a:cxnSpLocks/>
          </p:cNvCxnSpPr>
          <p:nvPr/>
        </p:nvCxnSpPr>
        <p:spPr>
          <a:xfrm>
            <a:off x="5931819" y="4896367"/>
            <a:ext cx="1268870" cy="7895"/>
          </a:xfrm>
          <a:prstGeom prst="line">
            <a:avLst/>
          </a:prstGeom>
          <a:ln w="381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E5922652-E16C-4985-9FBB-B192F8EC4304}"/>
              </a:ext>
            </a:extLst>
          </p:cNvPr>
          <p:cNvCxnSpPr>
            <a:cxnSpLocks/>
          </p:cNvCxnSpPr>
          <p:nvPr/>
        </p:nvCxnSpPr>
        <p:spPr>
          <a:xfrm>
            <a:off x="6647829" y="4879327"/>
            <a:ext cx="0" cy="1021124"/>
          </a:xfrm>
          <a:prstGeom prst="straightConnector1">
            <a:avLst/>
          </a:prstGeom>
          <a:ln w="3810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544AF723-C7F8-4BE0-9780-FC1E21D3F8C5}"/>
              </a:ext>
            </a:extLst>
          </p:cNvPr>
          <p:cNvCxnSpPr>
            <a:cxnSpLocks/>
          </p:cNvCxnSpPr>
          <p:nvPr/>
        </p:nvCxnSpPr>
        <p:spPr>
          <a:xfrm flipH="1">
            <a:off x="6662883" y="4896367"/>
            <a:ext cx="247584" cy="910953"/>
          </a:xfrm>
          <a:prstGeom prst="straightConnector1">
            <a:avLst/>
          </a:prstGeom>
          <a:ln w="3810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2" name="Picture 21" descr="A picture containing indoor&#10;&#10;Description automatically generated">
            <a:extLst>
              <a:ext uri="{FF2B5EF4-FFF2-40B4-BE49-F238E27FC236}">
                <a16:creationId xmlns:a16="http://schemas.microsoft.com/office/drawing/2014/main" id="{4EC88289-E294-18D2-0968-0E714F3B38C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1732" y="762960"/>
            <a:ext cx="4710098" cy="2830500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21BC20AC-9FA2-2DC6-D460-E7EFD9D613B5}"/>
              </a:ext>
            </a:extLst>
          </p:cNvPr>
          <p:cNvSpPr txBox="1"/>
          <p:nvPr/>
        </p:nvSpPr>
        <p:spPr>
          <a:xfrm>
            <a:off x="2989850" y="1064621"/>
            <a:ext cx="6581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68579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oil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A9065B8-4C76-0835-95A8-225E2CBD4E66}"/>
              </a:ext>
            </a:extLst>
          </p:cNvPr>
          <p:cNvSpPr txBox="1"/>
          <p:nvPr/>
        </p:nvSpPr>
        <p:spPr>
          <a:xfrm>
            <a:off x="3834244" y="17465"/>
            <a:ext cx="3942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Online Resource 3b</a:t>
            </a:r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ED7238C9-BA2F-B148-B088-9F7A165B19BB}"/>
              </a:ext>
            </a:extLst>
          </p:cNvPr>
          <p:cNvCxnSpPr>
            <a:cxnSpLocks/>
          </p:cNvCxnSpPr>
          <p:nvPr/>
        </p:nvCxnSpPr>
        <p:spPr>
          <a:xfrm flipH="1">
            <a:off x="3121056" y="1294362"/>
            <a:ext cx="33025" cy="564140"/>
          </a:xfrm>
          <a:prstGeom prst="straightConnector1">
            <a:avLst/>
          </a:prstGeom>
          <a:ln w="190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88A0A5FA-164F-A04A-B348-6B681E75F963}"/>
              </a:ext>
            </a:extLst>
          </p:cNvPr>
          <p:cNvCxnSpPr>
            <a:cxnSpLocks/>
          </p:cNvCxnSpPr>
          <p:nvPr/>
        </p:nvCxnSpPr>
        <p:spPr>
          <a:xfrm>
            <a:off x="3189040" y="1270594"/>
            <a:ext cx="150847" cy="564140"/>
          </a:xfrm>
          <a:prstGeom prst="straightConnector1">
            <a:avLst/>
          </a:prstGeom>
          <a:ln w="190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AC4A320C-6359-494C-80B4-D77D24027B95}"/>
              </a:ext>
            </a:extLst>
          </p:cNvPr>
          <p:cNvSpPr txBox="1"/>
          <p:nvPr/>
        </p:nvSpPr>
        <p:spPr>
          <a:xfrm>
            <a:off x="4769384" y="1064621"/>
            <a:ext cx="11624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alloon Catheter</a:t>
            </a: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9835C6EE-B385-D141-8F1B-31EDA7785BA4}"/>
              </a:ext>
            </a:extLst>
          </p:cNvPr>
          <p:cNvCxnSpPr>
            <a:cxnSpLocks/>
          </p:cNvCxnSpPr>
          <p:nvPr/>
        </p:nvCxnSpPr>
        <p:spPr>
          <a:xfrm>
            <a:off x="5148537" y="1529181"/>
            <a:ext cx="131094" cy="422056"/>
          </a:xfrm>
          <a:prstGeom prst="straightConnector1">
            <a:avLst/>
          </a:prstGeom>
          <a:ln w="190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2353B955-F14F-0848-886C-83246AC2D8FB}"/>
              </a:ext>
            </a:extLst>
          </p:cNvPr>
          <p:cNvSpPr txBox="1"/>
          <p:nvPr/>
        </p:nvSpPr>
        <p:spPr>
          <a:xfrm>
            <a:off x="1856711" y="3615570"/>
            <a:ext cx="30110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iii)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FA757BA-6961-E54D-98A0-51F11FE1B4E1}"/>
              </a:ext>
            </a:extLst>
          </p:cNvPr>
          <p:cNvSpPr txBox="1"/>
          <p:nvPr/>
        </p:nvSpPr>
        <p:spPr>
          <a:xfrm>
            <a:off x="5914683" y="412199"/>
            <a:ext cx="6125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ii)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29B9D65-EAD9-5646-B87D-6C822F83DAAF}"/>
              </a:ext>
            </a:extLst>
          </p:cNvPr>
          <p:cNvSpPr txBox="1"/>
          <p:nvPr/>
        </p:nvSpPr>
        <p:spPr>
          <a:xfrm>
            <a:off x="-1717511" y="393628"/>
            <a:ext cx="3942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</a:t>
            </a:r>
            <a:r>
              <a:rPr kumimoji="0" lang="en-AU" sz="18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</a:t>
            </a:r>
            <a:r>
              <a:rPr kumimoji="0" lang="en-AU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3348209C-EADB-49A9-B61B-BA50E552791E}"/>
              </a:ext>
            </a:extLst>
          </p:cNvPr>
          <p:cNvCxnSpPr>
            <a:cxnSpLocks/>
          </p:cNvCxnSpPr>
          <p:nvPr/>
        </p:nvCxnSpPr>
        <p:spPr>
          <a:xfrm>
            <a:off x="6341800" y="4878502"/>
            <a:ext cx="306029" cy="928818"/>
          </a:xfrm>
          <a:prstGeom prst="straightConnector1">
            <a:avLst/>
          </a:prstGeom>
          <a:ln w="3810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3706002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28" dur="4619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9" fill="hold">
                      <p:stCondLst>
                        <p:cond delay="indefinite"/>
                      </p:stCondLst>
                      <p:childTnLst>
                        <p:par>
                          <p:cTn id="30" fill="hold">
                            <p:stCondLst>
                              <p:cond delay="0"/>
                            </p:stCondLst>
                            <p:childTnLst>
                              <p:par>
                                <p:cTn id="31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3" dur="5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4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6" dur="5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7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9" dur="500"/>
                                        <p:tgtEl>
                                          <p:spTgt spid="2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0" presetID="10" presetClass="entr" presetSubtype="0" fill="hold" grpId="2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2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5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7" dur="5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8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0" dur="5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1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3" dur="500"/>
                                        <p:tgtEl>
                                          <p:spTgt spid="1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4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6" dur="500"/>
                                        <p:tgtEl>
                                          <p:spTgt spid="1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7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9" dur="500"/>
                                        <p:tgtEl>
                                          <p:spTgt spid="1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60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62" dur="5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3" fill="hold">
                      <p:stCondLst>
                        <p:cond delay="indefinite"/>
                      </p:stCondLst>
                      <p:childTnLst>
                        <p:par>
                          <p:cTn id="64" fill="hold">
                            <p:stCondLst>
                              <p:cond delay="0"/>
                            </p:stCondLst>
                            <p:childTnLst>
                              <p:par>
                                <p:cTn id="6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7" presetID="0" presetClass="path" presetSubtype="0" accel="50000" decel="5000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875E-6 -3.7037E-7 L 0.28229 -0.00162 " pathEditMode="relative" rAng="0" ptsTypes="AA">
                                      <p:cBhvr>
                                        <p:cTn id="68" dur="2000" fill="hold"/>
                                        <p:tgtEl>
                                          <p:spTgt spid="10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4115" y="-93"/>
                                    </p:animMotion>
                                  </p:childTnLst>
                                </p:cTn>
                              </p:par>
                              <p:par>
                                <p:cTn id="69" presetID="9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dissolve">
                                      <p:cBhvr>
                                        <p:cTn id="70" dur="30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71" dur="1" fill="hold">
                                          <p:stCondLst>
                                            <p:cond delay="2999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2" presetID="9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dissolve">
                                      <p:cBhvr>
                                        <p:cTn id="73" dur="3000"/>
                                        <p:tgtEl>
                                          <p:spTgt spid="21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74" dur="1" fill="hold">
                                          <p:stCondLst>
                                            <p:cond delay="2999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5" fill="hold">
                      <p:stCondLst>
                        <p:cond delay="indefinite"/>
                      </p:stCondLst>
                      <p:childTnLst>
                        <p:par>
                          <p:cTn id="76" fill="hold">
                            <p:stCondLst>
                              <p:cond delay="0"/>
                            </p:stCondLst>
                            <p:childTnLst>
                              <p:par>
                                <p:cTn id="7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9" fill="hold">
                      <p:stCondLst>
                        <p:cond delay="indefinite"/>
                      </p:stCondLst>
                      <p:childTnLst>
                        <p:par>
                          <p:cTn id="80" fill="hold">
                            <p:stCondLst>
                              <p:cond delay="0"/>
                            </p:stCondLst>
                            <p:childTnLst>
                              <p:par>
                                <p:cTn id="8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3" fill="hold">
                      <p:stCondLst>
                        <p:cond delay="indefinite"/>
                      </p:stCondLst>
                      <p:childTnLst>
                        <p:par>
                          <p:cTn id="84" fill="hold">
                            <p:stCondLst>
                              <p:cond delay="0"/>
                            </p:stCondLst>
                            <p:childTnLst>
                              <p:par>
                                <p:cTn id="85" presetID="1" presetClass="entr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7" fill="hold">
                      <p:stCondLst>
                        <p:cond delay="indefinite"/>
                      </p:stCondLst>
                      <p:childTnLst>
                        <p:par>
                          <p:cTn id="88" fill="hold">
                            <p:stCondLst>
                              <p:cond delay="0"/>
                            </p:stCondLst>
                            <p:childTnLst>
                              <p:par>
                                <p:cTn id="8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1" fill="hold">
                      <p:stCondLst>
                        <p:cond delay="indefinite"/>
                      </p:stCondLst>
                      <p:childTnLst>
                        <p:par>
                          <p:cTn id="92" fill="hold">
                            <p:stCondLst>
                              <p:cond delay="0"/>
                            </p:stCondLst>
                            <p:childTnLst>
                              <p:par>
                                <p:cTn id="9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5" fill="hold">
                      <p:stCondLst>
                        <p:cond delay="indefinite"/>
                      </p:stCondLst>
                      <p:childTnLst>
                        <p:par>
                          <p:cTn id="96" fill="hold">
                            <p:stCondLst>
                              <p:cond delay="0"/>
                            </p:stCondLst>
                            <p:childTnLst>
                              <p:par>
                                <p:cTn id="9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9" fill="hold">
                      <p:stCondLst>
                        <p:cond delay="indefinite"/>
                      </p:stCondLst>
                      <p:childTnLst>
                        <p:par>
                          <p:cTn id="100" fill="hold">
                            <p:stCondLst>
                              <p:cond delay="0"/>
                            </p:stCondLst>
                            <p:childTnLst>
                              <p:par>
                                <p:cTn id="10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03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  <p:bldLst>
      <p:bldP spid="8" grpId="0" animBg="1"/>
      <p:bldP spid="10" grpId="0" animBg="1"/>
      <p:bldP spid="10" grpId="1" animBg="1"/>
      <p:bldP spid="10" grpId="2" animBg="1"/>
      <p:bldP spid="15" grpId="0" animBg="1"/>
      <p:bldP spid="16" grpId="0" animBg="1"/>
      <p:bldP spid="18" grpId="0"/>
      <p:bldP spid="24" grpId="0"/>
      <p:bldP spid="24" grpId="1"/>
      <p:bldP spid="7" grpId="0"/>
      <p:bldP spid="32" grpId="0"/>
      <p:bldP spid="33" grpId="0"/>
      <p:bldP spid="34" grpId="0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23</Words>
  <Application>Microsoft Office PowerPoint</Application>
  <PresentationFormat>Widescreen</PresentationFormat>
  <Paragraphs>11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Monash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Dear</dc:creator>
  <cp:lastModifiedBy>Anthony Dear</cp:lastModifiedBy>
  <cp:revision>4</cp:revision>
  <dcterms:created xsi:type="dcterms:W3CDTF">2023-01-04T23:35:19Z</dcterms:created>
  <dcterms:modified xsi:type="dcterms:W3CDTF">2023-01-05T00:22:05Z</dcterms:modified>
</cp:coreProperties>
</file>